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03" r:id="rId2"/>
    <p:sldId id="302" r:id="rId3"/>
    <p:sldId id="304" r:id="rId4"/>
    <p:sldId id="30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5" autoAdjust="0"/>
    <p:restoredTop sz="94673" autoAdjust="0"/>
  </p:normalViewPr>
  <p:slideViewPr>
    <p:cSldViewPr snapToGrid="0">
      <p:cViewPr>
        <p:scale>
          <a:sx n="80" d="100"/>
          <a:sy n="80" d="100"/>
        </p:scale>
        <p:origin x="297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CA2779-2222-4C63-B95B-BE365B8A0CD7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0B3771-C358-4981-B872-6D51429E2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574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0B3771-C358-4981-B872-6D51429E278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291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38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24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3305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501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5629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640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18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376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755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604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887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AA89B-164F-4BDF-949E-F845BA139EAF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6D1A40-6B54-4FFC-93DF-B40C6BD10F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9536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91" y="541550"/>
            <a:ext cx="5865369" cy="351922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93" y="5029459"/>
            <a:ext cx="6003867" cy="3274836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0" y="8783704"/>
            <a:ext cx="6908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7568" y="191947"/>
            <a:ext cx="61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5318" y="4620917"/>
            <a:ext cx="49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7221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0" y="8783704"/>
            <a:ext cx="6908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7568" y="191947"/>
            <a:ext cx="6156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0222" y="4763124"/>
            <a:ext cx="49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77" y="572188"/>
            <a:ext cx="5791200" cy="34747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127" y="5215281"/>
            <a:ext cx="6001512" cy="3273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3914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04" y="596900"/>
            <a:ext cx="5804290" cy="348257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649" y="5060354"/>
            <a:ext cx="5765800" cy="314498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0" y="8777138"/>
            <a:ext cx="6908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7568" y="191947"/>
            <a:ext cx="6156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82877" y="4752577"/>
            <a:ext cx="49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556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9236" y="8966200"/>
            <a:ext cx="68487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7568" y="191947"/>
            <a:ext cx="6156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0222" y="4702401"/>
            <a:ext cx="4903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049" y="680147"/>
            <a:ext cx="5151120" cy="309067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862" y="5237668"/>
            <a:ext cx="6001512" cy="3273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1968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05</TotalTime>
  <Words>37</Words>
  <Application>Microsoft Office PowerPoint</Application>
  <PresentationFormat>A4 Paper (210x297 mm)</PresentationFormat>
  <Paragraphs>1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zhixue</dc:creator>
  <cp:lastModifiedBy>Beenish</cp:lastModifiedBy>
  <cp:revision>376</cp:revision>
  <dcterms:created xsi:type="dcterms:W3CDTF">2022-01-03T08:55:19Z</dcterms:created>
  <dcterms:modified xsi:type="dcterms:W3CDTF">2024-12-06T08:56:53Z</dcterms:modified>
</cp:coreProperties>
</file>